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2009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5464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039696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67515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351955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554903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711097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929811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31907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05417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3480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56202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211540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913407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9640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7806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6688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0496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830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6696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8530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0019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881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04382-B6E4-409B-8D5D-8C2C75CEF34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7/20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49CFC-F900-4FDB-ABDC-D30A4705353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73111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2152650" y="79377"/>
            <a:ext cx="7886700" cy="937894"/>
          </a:xfrm>
        </p:spPr>
        <p:txBody>
          <a:bodyPr>
            <a:normAutofit/>
          </a:bodyPr>
          <a:lstStyle/>
          <a:p>
            <a:r>
              <a:rPr lang="en-US" sz="3200" b="1" dirty="0"/>
              <a:t>Opioid-Related Death Rates by State: 2017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989558"/>
            <a:ext cx="9144000" cy="52283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01240" y="6217920"/>
            <a:ext cx="7280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Calibri" panose="020F0502020204030204"/>
              </a:rPr>
              <a:t>Source:  CDC 2017 multiple causes of death </a:t>
            </a:r>
            <a:r>
              <a:rPr lang="en-US" dirty="0" smtClean="0">
                <a:solidFill>
                  <a:prstClr val="black"/>
                </a:solidFill>
                <a:latin typeface="Calibri" panose="020F0502020204030204"/>
              </a:rPr>
              <a:t>data</a:t>
            </a:r>
            <a:endParaRPr lang="en-US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951143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1866900" y="79377"/>
            <a:ext cx="8172450" cy="937894"/>
          </a:xfrm>
        </p:spPr>
        <p:txBody>
          <a:bodyPr>
            <a:normAutofit/>
          </a:bodyPr>
          <a:lstStyle/>
          <a:p>
            <a:r>
              <a:rPr lang="en-US" sz="3200" b="1" dirty="0"/>
              <a:t>Number of Opioid-Related Deaths by State: 201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01240" y="6217920"/>
            <a:ext cx="7280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Calibri" panose="020F0502020204030204"/>
              </a:rPr>
              <a:t>Source:  CDC 2017 multiple causes of death data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989558"/>
            <a:ext cx="9144000" cy="5228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772063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1_Office Theme</vt:lpstr>
      <vt:lpstr>Office Theme</vt:lpstr>
      <vt:lpstr>Opioid-Related Death Rates by State: 2017</vt:lpstr>
      <vt:lpstr>Number of Opioid-Related Deaths by State: 2017</vt:lpstr>
    </vt:vector>
  </TitlesOfParts>
  <Company>Chestnut Health System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pioid-Related Death Rates by State: 2017</dc:title>
  <dc:creator>Christine Grella</dc:creator>
  <cp:lastModifiedBy>Chris</cp:lastModifiedBy>
  <cp:revision>2</cp:revision>
  <dcterms:created xsi:type="dcterms:W3CDTF">2021-04-13T16:37:58Z</dcterms:created>
  <dcterms:modified xsi:type="dcterms:W3CDTF">2021-06-17T17:52:39Z</dcterms:modified>
</cp:coreProperties>
</file>